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ADE2D-1568-435C-AEB5-21BC0C7124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39067F-A1DC-42BA-89C9-B7EE5A04A9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3A4BE-F56E-4DD8-B098-67DB703010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A2720C-C1B2-4CA2-8DBD-2E0C85E4CE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AE58F-43AD-4D72-BD30-9179E1E366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642F3-9199-421A-86EA-2AB46060E9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EAAF0-F647-48FE-9C3C-28106DB0B6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3FE41-99BA-4FED-9BE5-93BB9B0ABD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E980B-E415-471F-ADEA-C96F724902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51807-7392-43A3-B725-084DB6D6CE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D17E1B-DE83-4135-8DA9-CA1D542A1F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FB13B8-E17C-46CC-9A1C-C28B2E9B15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8FB5FE-0D9C-4559-9248-427CCD3853E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484360" y="981000"/>
          <a:ext cx="4208400" cy="3192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484360" y="981000"/>
                    <a:ext cx="4208400" cy="3192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1315440" y="4508640"/>
            <a:ext cx="68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FIGURE S1 | Rarefaction curves of the sequencing effort on the estimation of the number of OT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6T01:30:27Z</dcterms:created>
  <dc:creator>Administrator</dc:creator>
  <dc:description/>
  <dc:language>en-US</dc:language>
  <cp:lastModifiedBy/>
  <dcterms:modified xsi:type="dcterms:W3CDTF">2017-05-23T12:09:02Z</dcterms:modified>
  <cp:revision>0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KSOProductBuildVer">
    <vt:lpwstr>2052-9.1.0.4472</vt:lpwstr>
  </property>
  <property fmtid="{D5CDD505-2E9C-101B-9397-08002B2CF9AE}" pid="6" name="TitleName">
    <vt:lpwstr>Presentation 1.PPT</vt:lpwstr>
  </property>
</Properties>
</file>